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3" d="100"/>
          <a:sy n="93" d="100"/>
        </p:scale>
        <p:origin x="27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8B569-D49A-E062-300B-897A1C654B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642931-1980-F5F8-37F8-19F839C6F0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4E5922-38CC-BF41-6C42-55CEFC7C0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48A0D-4A7E-2BCB-496B-8D0BBA919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48DA65-BF9E-75B2-1662-0094EF785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7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4067C-A827-872C-8F3F-D119129993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085E60-A826-3B77-D3BE-860C1FA666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82C427-DC80-1CE2-D62F-0B4C09688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299E34-3F20-1662-8983-A35BBB6FB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2613D-4C5D-EFCB-3D32-8FC6521A4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615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25C0B8-B3ED-294E-77AB-ED471E6DC8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65A82F-F11E-C508-2355-F1E16E3C1B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809A1-88CD-5EAF-030A-0C68020CA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27757-FFF5-E9A9-78CF-D478086A4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AB2FE7-90DB-880F-099A-881F96C92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3110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DAFDA-BC5B-7D74-FF9A-183BDCE57E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3DBA94-7D97-6AA7-CCDF-7DC666AF3C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87358-5AAA-78B7-CB9F-FE12A601B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F271B6-AC88-7396-7663-37802C1F0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152CEB-080D-50FF-E9CE-4EAD9C60E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6330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27BBC-51D9-8470-FCD0-C9A2C80BD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2589F8-F141-C9D8-39F5-5422DD435A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A3737F-4E7B-9312-23AA-0EC3510E2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7BD742-6880-D1DA-F361-BAE3BD20B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2D4965-6CBE-192B-DA42-2758AF684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677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CA0F62-7C48-4105-5A7A-553EE5A2F9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FC242F-85F0-2752-7BDC-083B186D27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C48508-D5D4-AB44-ED74-7DF8FA5141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E05997-4C58-C2C0-E853-322EBECD3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483AAE-EDDC-D5CA-A149-62A13E996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CA9C26-9F80-EC21-3932-9B7165485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116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1BA39-0C91-C879-9D3A-50FFF5196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254B49-E706-0D13-D23B-EC3A97A27E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1FD46C-F59A-D885-7912-64A5DC627D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1E81B9-2290-06F0-CDA8-5CB28561D4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501FD8-E75E-6E07-F21A-8E5A2ABDC6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EC4381-A81D-7C31-C538-5ABF8D057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6828FF-940F-95CD-458D-7568BB5CB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B01B61B-720B-3AF7-B554-F125D788F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8747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6BDFA-FDFE-7B11-BA3D-1B58ED5691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BE7B8D-6424-3D60-3E33-A72062E03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270723-CBCE-CBF6-F03B-1FE762F92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4405FD-70DA-E48A-8DC5-1EDE8280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1164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EDBB37-E697-1272-BA6F-A657DFCF5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60A885-85DA-AA05-1AAA-3E7389556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CDA626-F2A1-46F8-377E-C27FDAFFD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5398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2415C8-F06B-CB7B-8618-6B853C0852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6AADC-6E58-188D-4CD7-3C722605E8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5B020A-BEB5-835A-EE95-4FEFCA1C15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CC0388-484A-F651-D99F-107088261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971457-07FB-10C1-9E38-8CA7D6881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DE1885-F09B-D267-85E1-3C4781464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893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0D1A2-FD45-1DA7-4933-62DE477FF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4E45E5-6224-8693-8BA1-525A583A74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DF748A-B35C-3FC8-0A6A-9E5CA38138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8C985C-441A-AEB5-9A11-FA55AA0B6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D39924-0DF3-A0E3-A703-AA347FDFD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4DE035-2A1D-D5E2-595C-D9E8C3A19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706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F237B3-FC45-C8F2-77E8-CA510034DE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4B0802-09E2-F9E6-6556-2A4B8C3242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C4EED8-25D8-519A-395A-B6809E2382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A8C1B80-7FBD-40E2-BC99-7C91A397E4DF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7CB3E4-19E1-0368-FCBB-D4DCED21B3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6AB110-7942-74D1-9C8A-F791003745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18368F-A90C-4C07-BBA0-69D27953F7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338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D429E81-5F58-1A25-6CD0-EEAFDFAA2A16}"/>
              </a:ext>
            </a:extLst>
          </p:cNvPr>
          <p:cNvSpPr txBox="1"/>
          <p:nvPr/>
        </p:nvSpPr>
        <p:spPr>
          <a:xfrm>
            <a:off x="0" y="68094"/>
            <a:ext cx="2151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lu6_biological replicate_n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22621" y="3680800"/>
            <a:ext cx="3886200" cy="2522435"/>
          </a:xfrm>
          <a:prstGeom prst="rect">
            <a:avLst/>
          </a:prstGeom>
          <a:noFill/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22621" y="788677"/>
            <a:ext cx="3886200" cy="252875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729802" y="788677"/>
            <a:ext cx="3886200" cy="250744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729802" y="3705863"/>
            <a:ext cx="3886200" cy="2497372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296DD818-05AC-1BB3-DF1A-D522B2569391}"/>
              </a:ext>
            </a:extLst>
          </p:cNvPr>
          <p:cNvSpPr/>
          <p:nvPr/>
        </p:nvSpPr>
        <p:spPr>
          <a:xfrm>
            <a:off x="1143000" y="4868333"/>
            <a:ext cx="141467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AA6ED5-25FB-15DA-7925-16033204461A}"/>
              </a:ext>
            </a:extLst>
          </p:cNvPr>
          <p:cNvSpPr txBox="1"/>
          <p:nvPr/>
        </p:nvSpPr>
        <p:spPr>
          <a:xfrm>
            <a:off x="2662175" y="4839128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>
                <a:solidFill>
                  <a:srgbClr val="FF0000"/>
                </a:solidFill>
              </a:rPr>
              <a:t>β</a:t>
            </a:r>
            <a:r>
              <a:rPr lang="en-GB" sz="11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6199287-5B30-9284-809E-89D2A7129C8B}"/>
              </a:ext>
            </a:extLst>
          </p:cNvPr>
          <p:cNvSpPr/>
          <p:nvPr/>
        </p:nvSpPr>
        <p:spPr>
          <a:xfrm>
            <a:off x="5279558" y="4635928"/>
            <a:ext cx="141467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29003C-0E25-BF0F-B4E1-2F411D5DBC76}"/>
              </a:ext>
            </a:extLst>
          </p:cNvPr>
          <p:cNvSpPr txBox="1"/>
          <p:nvPr/>
        </p:nvSpPr>
        <p:spPr>
          <a:xfrm>
            <a:off x="6798733" y="4606723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3B71EBD-4BD2-0AB2-8F93-9B9C16E9A6BA}"/>
              </a:ext>
            </a:extLst>
          </p:cNvPr>
          <p:cNvSpPr/>
          <p:nvPr/>
        </p:nvSpPr>
        <p:spPr>
          <a:xfrm>
            <a:off x="1236132" y="1869012"/>
            <a:ext cx="1321537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B09CC7F-3C4D-26CF-6ABD-2D2B8BF769AF}"/>
              </a:ext>
            </a:extLst>
          </p:cNvPr>
          <p:cNvSpPr txBox="1"/>
          <p:nvPr/>
        </p:nvSpPr>
        <p:spPr>
          <a:xfrm>
            <a:off x="2716399" y="1869012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LMP2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D127DEF-7D07-8C41-52E7-EC0C3A9E10E2}"/>
              </a:ext>
            </a:extLst>
          </p:cNvPr>
          <p:cNvSpPr/>
          <p:nvPr/>
        </p:nvSpPr>
        <p:spPr>
          <a:xfrm>
            <a:off x="4859215" y="1013878"/>
            <a:ext cx="129132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1984667-703B-89B5-856F-0A40420379CD}"/>
              </a:ext>
            </a:extLst>
          </p:cNvPr>
          <p:cNvSpPr txBox="1"/>
          <p:nvPr/>
        </p:nvSpPr>
        <p:spPr>
          <a:xfrm>
            <a:off x="6189120" y="984673"/>
            <a:ext cx="5982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HIF-1</a:t>
            </a:r>
            <a:r>
              <a:rPr lang="el-GR" sz="1100" dirty="0">
                <a:solidFill>
                  <a:srgbClr val="FF0000"/>
                </a:solidFill>
              </a:rPr>
              <a:t>α</a:t>
            </a:r>
            <a:endParaRPr lang="en-GB" sz="11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10804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DC5DA7-FE4F-9A59-90AA-963475456643}"/>
              </a:ext>
            </a:extLst>
          </p:cNvPr>
          <p:cNvSpPr txBox="1"/>
          <p:nvPr/>
        </p:nvSpPr>
        <p:spPr>
          <a:xfrm>
            <a:off x="0" y="68094"/>
            <a:ext cx="2151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lu6_biological replicate_n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5567" y="683826"/>
            <a:ext cx="3667125" cy="242441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106675" y="683826"/>
            <a:ext cx="3667126" cy="2428148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38F8C6CB-4368-6C8A-0843-301D5A107FF0}"/>
              </a:ext>
            </a:extLst>
          </p:cNvPr>
          <p:cNvSpPr/>
          <p:nvPr/>
        </p:nvSpPr>
        <p:spPr>
          <a:xfrm>
            <a:off x="563779" y="1833153"/>
            <a:ext cx="1278947" cy="26161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FE3192-8B6E-A400-F2BF-F175FCA11328}"/>
              </a:ext>
            </a:extLst>
          </p:cNvPr>
          <p:cNvSpPr txBox="1"/>
          <p:nvPr/>
        </p:nvSpPr>
        <p:spPr>
          <a:xfrm>
            <a:off x="1842726" y="1833153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LMP2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9B0BC09-9E57-6F94-D3C7-7A8C5C3076E3}"/>
              </a:ext>
            </a:extLst>
          </p:cNvPr>
          <p:cNvSpPr/>
          <p:nvPr/>
        </p:nvSpPr>
        <p:spPr>
          <a:xfrm>
            <a:off x="4554070" y="1369966"/>
            <a:ext cx="1290917" cy="1898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C6B791-5571-93C7-3283-A318BB769293}"/>
              </a:ext>
            </a:extLst>
          </p:cNvPr>
          <p:cNvSpPr txBox="1"/>
          <p:nvPr/>
        </p:nvSpPr>
        <p:spPr>
          <a:xfrm>
            <a:off x="5844987" y="1334108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5DAF8C0-686F-C759-440E-F598265A45D1}"/>
              </a:ext>
            </a:extLst>
          </p:cNvPr>
          <p:cNvSpPr/>
          <p:nvPr/>
        </p:nvSpPr>
        <p:spPr>
          <a:xfrm>
            <a:off x="563779" y="1467233"/>
            <a:ext cx="1278947" cy="17377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50B07EA-798B-AB64-CE73-87E6D999469F}"/>
              </a:ext>
            </a:extLst>
          </p:cNvPr>
          <p:cNvSpPr txBox="1"/>
          <p:nvPr/>
        </p:nvSpPr>
        <p:spPr>
          <a:xfrm>
            <a:off x="1808772" y="1423317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728737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0683" y="452925"/>
            <a:ext cx="4391596" cy="29760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762923" y="452924"/>
            <a:ext cx="4389153" cy="297607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1D06688-8A19-501C-C48F-1B885433B6A0}"/>
              </a:ext>
            </a:extLst>
          </p:cNvPr>
          <p:cNvSpPr txBox="1"/>
          <p:nvPr/>
        </p:nvSpPr>
        <p:spPr>
          <a:xfrm>
            <a:off x="0" y="68094"/>
            <a:ext cx="2151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lu6_biological replicate_n3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887AB70-8465-0CAE-D107-A48FC2F6741E}"/>
              </a:ext>
            </a:extLst>
          </p:cNvPr>
          <p:cNvSpPr/>
          <p:nvPr/>
        </p:nvSpPr>
        <p:spPr>
          <a:xfrm>
            <a:off x="5270593" y="1839361"/>
            <a:ext cx="141467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E92590-7571-DF32-6FE5-87201E179669}"/>
              </a:ext>
            </a:extLst>
          </p:cNvPr>
          <p:cNvSpPr txBox="1"/>
          <p:nvPr/>
        </p:nvSpPr>
        <p:spPr>
          <a:xfrm>
            <a:off x="6069389" y="2072563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>
                <a:solidFill>
                  <a:srgbClr val="FF0000"/>
                </a:solidFill>
              </a:rPr>
              <a:t>β</a:t>
            </a:r>
            <a:r>
              <a:rPr lang="en-GB" sz="11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C88A103-2B34-E416-AB79-CE9D1BBF9B0D}"/>
              </a:ext>
            </a:extLst>
          </p:cNvPr>
          <p:cNvSpPr/>
          <p:nvPr/>
        </p:nvSpPr>
        <p:spPr>
          <a:xfrm>
            <a:off x="5270593" y="1534140"/>
            <a:ext cx="141467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1AB8C3-3B47-93C0-1B77-E5A86E61058E}"/>
              </a:ext>
            </a:extLst>
          </p:cNvPr>
          <p:cNvSpPr txBox="1"/>
          <p:nvPr/>
        </p:nvSpPr>
        <p:spPr>
          <a:xfrm>
            <a:off x="6825627" y="1504935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TAP2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0D1ED8F-0E95-4E2A-7B5F-4764C41EDA89}"/>
              </a:ext>
            </a:extLst>
          </p:cNvPr>
          <p:cNvSpPr/>
          <p:nvPr/>
        </p:nvSpPr>
        <p:spPr>
          <a:xfrm>
            <a:off x="644462" y="1205623"/>
            <a:ext cx="1435350" cy="25562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F286F10-13A6-5149-40CE-BFDBE0FA922C}"/>
              </a:ext>
            </a:extLst>
          </p:cNvPr>
          <p:cNvSpPr txBox="1"/>
          <p:nvPr/>
        </p:nvSpPr>
        <p:spPr>
          <a:xfrm>
            <a:off x="2197392" y="1205623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LMP2</a:t>
            </a:r>
          </a:p>
        </p:txBody>
      </p:sp>
      <p:pic>
        <p:nvPicPr>
          <p:cNvPr id="17" name="Picture 16" descr="A black and white photo of a person standing on a white surface&#10;&#10;Description automatically generated">
            <a:extLst>
              <a:ext uri="{FF2B5EF4-FFF2-40B4-BE49-F238E27FC236}">
                <a16:creationId xmlns:a16="http://schemas.microsoft.com/office/drawing/2014/main" id="{C4161C37-7C8A-1E2D-666A-867692EAE8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20" y="3536832"/>
            <a:ext cx="4399759" cy="2351823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0B30FD1B-7322-50FC-A75D-DAF402313638}"/>
              </a:ext>
            </a:extLst>
          </p:cNvPr>
          <p:cNvSpPr/>
          <p:nvPr/>
        </p:nvSpPr>
        <p:spPr>
          <a:xfrm>
            <a:off x="451972" y="5009230"/>
            <a:ext cx="1291320" cy="2032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8E8BE2-DA8B-E2CC-811C-AE7B777A53E9}"/>
              </a:ext>
            </a:extLst>
          </p:cNvPr>
          <p:cNvSpPr txBox="1"/>
          <p:nvPr/>
        </p:nvSpPr>
        <p:spPr>
          <a:xfrm>
            <a:off x="1781877" y="4980025"/>
            <a:ext cx="5982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srgbClr val="FF0000"/>
                </a:solidFill>
              </a:rPr>
              <a:t>HIF-1</a:t>
            </a:r>
            <a:r>
              <a:rPr lang="el-GR" sz="1100" dirty="0">
                <a:solidFill>
                  <a:srgbClr val="FF0000"/>
                </a:solidFill>
              </a:rPr>
              <a:t>α</a:t>
            </a:r>
            <a:endParaRPr lang="en-GB" sz="11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1945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33</Words>
  <Application>Microsoft Office PowerPoint</Application>
  <PresentationFormat>Widescreen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4</cp:revision>
  <dcterms:created xsi:type="dcterms:W3CDTF">2024-09-01T09:26:50Z</dcterms:created>
  <dcterms:modified xsi:type="dcterms:W3CDTF">2024-09-01T09:50:59Z</dcterms:modified>
</cp:coreProperties>
</file>